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6" d="100"/>
          <a:sy n="116" d="100"/>
        </p:scale>
        <p:origin x="2070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4B7623-63E7-487D-973E-53E6C372B7BE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51D87F-BB39-43FA-B991-5F9C768E80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0338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8768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2383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648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85393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268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8206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41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731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9419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164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398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8290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25061433"/>
              </p:ext>
            </p:extLst>
          </p:nvPr>
        </p:nvGraphicFramePr>
        <p:xfrm>
          <a:off x="609600" y="132457"/>
          <a:ext cx="1998663" cy="42250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8" name="SPW 13.0 Graph" r:id="rId3" imgW="3554145" imgH="7513151" progId="SigmaPlotGraphicObject.12">
                  <p:embed/>
                </p:oleObj>
              </mc:Choice>
              <mc:Fallback>
                <p:oleObj name="SPW 13.0 Graph" r:id="rId3" imgW="3554145" imgH="7513151" progId="SigmaPlotGraphicObjec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09600" y="132457"/>
                        <a:ext cx="1998663" cy="42250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500200" y="4343400"/>
            <a:ext cx="78486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smtClean="0">
                <a:latin typeface="Arial" panose="020B0604020202020204" pitchFamily="34" charset="0"/>
                <a:cs typeface="Arial" panose="020B0604020202020204" pitchFamily="34" charset="0"/>
              </a:rPr>
              <a:t>S2 Fig. 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sulin levels after glucose or insulin administration in male mice. 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. After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 5 hour fast, baselin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suli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a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easured, and mal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lpp3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lang="en-US" sz="1200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; black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ars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P2-Cre/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lpp3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Δ; ope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ars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jecte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ith glucose (2 g/kg body weight) in isotonic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aline.  Measurement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bloo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sulin levels (ng/ml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re mad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or up to 30 min and the area under the curve present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s mean ±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D. Results were compared by two tailed t-test. B. Insulin tolerance testing was performed and blood glucose at the indicated time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male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lpp3</a:t>
            </a:r>
            <a:r>
              <a:rPr lang="en-US" sz="12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lang="en-US" sz="1200" i="1" baseline="30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2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; black symbols) and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P2-Cre/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lpp3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Δ; open symbols) mice are graphed as mean ± S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rom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ean area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der the curve (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C) is presented in C.  Results were compared by two-tailed t-tes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6 - 8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imals were used per condition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2801194"/>
              </p:ext>
            </p:extLst>
          </p:nvPr>
        </p:nvGraphicFramePr>
        <p:xfrm>
          <a:off x="2711694" y="1210335"/>
          <a:ext cx="3460506" cy="28676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9" name="SPW 13.0 Graph" r:id="rId5" imgW="6032161" imgH="4998810" progId="SigmaPlotGraphicObject.12">
                  <p:embed/>
                </p:oleObj>
              </mc:Choice>
              <mc:Fallback>
                <p:oleObj name="SPW 13.0 Graph" r:id="rId5" imgW="6032161" imgH="4998810" progId="SigmaPlotGraphicObjec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711694" y="1210335"/>
                        <a:ext cx="3460506" cy="28676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685800" y="933335"/>
            <a:ext cx="734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.  GTT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667000" y="933335"/>
            <a:ext cx="614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. ITT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6510542"/>
              </p:ext>
            </p:extLst>
          </p:nvPr>
        </p:nvGraphicFramePr>
        <p:xfrm>
          <a:off x="5797974" y="140868"/>
          <a:ext cx="2203026" cy="42245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0" name="SPW 13.0 Graph" r:id="rId7" imgW="3919588" imgH="7513151" progId="SigmaPlotGraphicObject.12">
                  <p:embed/>
                </p:oleObj>
              </mc:Choice>
              <mc:Fallback>
                <p:oleObj name="SPW 13.0 Graph" r:id="rId7" imgW="3919588" imgH="7513151" progId="SigmaPlotGraphicObjec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797974" y="140868"/>
                        <a:ext cx="2203026" cy="42245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5715000" y="933335"/>
            <a:ext cx="7079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. AU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835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8</TotalTime>
  <Words>173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Office Theme</vt:lpstr>
      <vt:lpstr>SPW 13.0 Graph</vt:lpstr>
      <vt:lpstr>PowerPoint Presentation</vt:lpstr>
    </vt:vector>
  </TitlesOfParts>
  <Company>University of Kentuck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myth, Susan</dc:creator>
  <cp:lastModifiedBy>McMullen, Colleen</cp:lastModifiedBy>
  <cp:revision>17</cp:revision>
  <dcterms:created xsi:type="dcterms:W3CDTF">2017-09-11T17:11:52Z</dcterms:created>
  <dcterms:modified xsi:type="dcterms:W3CDTF">2018-05-31T16:38:38Z</dcterms:modified>
  <cp:contentStatus>Final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MarkAsFinal">
    <vt:bool>true</vt:bool>
  </property>
</Properties>
</file>